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6"/>
  </p:notesMasterIdLst>
  <p:sldIdLst>
    <p:sldId id="265" r:id="rId2"/>
    <p:sldId id="266" r:id="rId3"/>
    <p:sldId id="269" r:id="rId4"/>
    <p:sldId id="268" r:id="rId5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F0000"/>
    <a:srgbClr val="BFBFB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06"/>
    <p:restoredTop sz="95335"/>
  </p:normalViewPr>
  <p:slideViewPr>
    <p:cSldViewPr snapToGrid="0" snapToObjects="1">
      <p:cViewPr varScale="1">
        <p:scale>
          <a:sx n="81" d="100"/>
          <a:sy n="81" d="100"/>
        </p:scale>
        <p:origin x="273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FILES/%20%20%20RESEARCH/%20%20%20%20%20B-amylase%20/%20%20%20%2019%20BAM/%20%20%20%20Multiple%20mutants/%20%20%20%20Multiple%20Mutants%20paper/eFP%20data%20light%20series%20diurnal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FILES/%20%20%20RESEARCH/%20%20%20%20%20B-amylase%20/%20%20%20%2019%20BAM/%20%20%20%20Multiple%20mutants/%20%20%20%20Multiple%20Mutants%20paper/eFP%20data%20light%20series%20diurnal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FILES/%20%20%20RESEARCH/%20%20%20%20%20B-amylase%20/%20%20%20%2019%20BAM/%20%20%20%20Multiple%20mutants/%20%20%20%20Multiple%20Mutants%20paper/eFP%20data%20light%20series%20diurnal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FILES/%20%20%20RESEARCH/%20%20%20%20%20B-amylase%20/%20%20%20%2019%20BAM/%20%20%20%20Multiple%20mutants/%20%20%20%20Multiple%20Mutants%20paper/eFP%20data%20light%20series%20diurnal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9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E$55:$E$61</c:f>
                <c:numCache>
                  <c:formatCode>General</c:formatCode>
                  <c:ptCount val="7"/>
                  <c:pt idx="0">
                    <c:v>826.46</c:v>
                  </c:pt>
                  <c:pt idx="1">
                    <c:v>115.78</c:v>
                  </c:pt>
                  <c:pt idx="2">
                    <c:v>140.84</c:v>
                  </c:pt>
                  <c:pt idx="3">
                    <c:v>407.81</c:v>
                  </c:pt>
                  <c:pt idx="4">
                    <c:v>436.42</c:v>
                  </c:pt>
                  <c:pt idx="5">
                    <c:v>805.21</c:v>
                  </c:pt>
                  <c:pt idx="6">
                    <c:v>826.46</c:v>
                  </c:pt>
                </c:numCache>
              </c:numRef>
            </c:plus>
            <c:minus>
              <c:numRef>
                <c:f>Sheet2!$E$55:$E$61</c:f>
                <c:numCache>
                  <c:formatCode>General</c:formatCode>
                  <c:ptCount val="7"/>
                  <c:pt idx="0">
                    <c:v>826.46</c:v>
                  </c:pt>
                  <c:pt idx="1">
                    <c:v>115.78</c:v>
                  </c:pt>
                  <c:pt idx="2">
                    <c:v>140.84</c:v>
                  </c:pt>
                  <c:pt idx="3">
                    <c:v>407.81</c:v>
                  </c:pt>
                  <c:pt idx="4">
                    <c:v>436.42</c:v>
                  </c:pt>
                  <c:pt idx="5">
                    <c:v>805.21</c:v>
                  </c:pt>
                  <c:pt idx="6">
                    <c:v>826.4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2!$B$55:$B$61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C$55:$C$61</c:f>
              <c:numCache>
                <c:formatCode>General</c:formatCode>
                <c:ptCount val="7"/>
                <c:pt idx="0">
                  <c:v>4347.91</c:v>
                </c:pt>
                <c:pt idx="1">
                  <c:v>971.61</c:v>
                </c:pt>
                <c:pt idx="2">
                  <c:v>1935.41</c:v>
                </c:pt>
                <c:pt idx="3">
                  <c:v>4251.37</c:v>
                </c:pt>
                <c:pt idx="4">
                  <c:v>2886.62</c:v>
                </c:pt>
                <c:pt idx="5">
                  <c:v>4481.87</c:v>
                </c:pt>
                <c:pt idx="6">
                  <c:v>4347.9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EAE-6149-B2FD-8D40981A4BFE}"/>
            </c:ext>
          </c:extLst>
        </c:ser>
        <c:ser>
          <c:idx val="1"/>
          <c:order val="1"/>
          <c:spPr>
            <a:ln w="19050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circle"/>
            <c:size val="9"/>
            <c:spPr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F$55:$F$61</c:f>
                <c:numCache>
                  <c:formatCode>General</c:formatCode>
                  <c:ptCount val="7"/>
                  <c:pt idx="0">
                    <c:v>1373.36</c:v>
                  </c:pt>
                  <c:pt idx="1">
                    <c:v>62.82</c:v>
                  </c:pt>
                  <c:pt idx="2">
                    <c:v>215.28</c:v>
                  </c:pt>
                  <c:pt idx="3">
                    <c:v>31.89</c:v>
                  </c:pt>
                  <c:pt idx="4">
                    <c:v>579.79</c:v>
                  </c:pt>
                  <c:pt idx="5">
                    <c:v>72.239999999999995</c:v>
                  </c:pt>
                  <c:pt idx="6">
                    <c:v>1373.36</c:v>
                  </c:pt>
                </c:numCache>
              </c:numRef>
            </c:plus>
            <c:minus>
              <c:numRef>
                <c:f>Sheet2!$F$55:$F$61</c:f>
                <c:numCache>
                  <c:formatCode>General</c:formatCode>
                  <c:ptCount val="7"/>
                  <c:pt idx="0">
                    <c:v>1373.36</c:v>
                  </c:pt>
                  <c:pt idx="1">
                    <c:v>62.82</c:v>
                  </c:pt>
                  <c:pt idx="2">
                    <c:v>215.28</c:v>
                  </c:pt>
                  <c:pt idx="3">
                    <c:v>31.89</c:v>
                  </c:pt>
                  <c:pt idx="4">
                    <c:v>579.79</c:v>
                  </c:pt>
                  <c:pt idx="5">
                    <c:v>72.239999999999995</c:v>
                  </c:pt>
                  <c:pt idx="6">
                    <c:v>1373.3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2!$B$55:$B$61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D$55:$D$61</c:f>
              <c:numCache>
                <c:formatCode>General</c:formatCode>
                <c:ptCount val="7"/>
                <c:pt idx="0">
                  <c:v>5665.06</c:v>
                </c:pt>
                <c:pt idx="1">
                  <c:v>2402.39</c:v>
                </c:pt>
                <c:pt idx="2">
                  <c:v>2686.71</c:v>
                </c:pt>
                <c:pt idx="3">
                  <c:v>3707.57</c:v>
                </c:pt>
                <c:pt idx="4">
                  <c:v>3027.29</c:v>
                </c:pt>
                <c:pt idx="5">
                  <c:v>4997.9799999999996</c:v>
                </c:pt>
                <c:pt idx="6">
                  <c:v>5665.0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EAE-6149-B2FD-8D40981A4BF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40697264"/>
        <c:axId val="1779507376"/>
      </c:scatterChart>
      <c:valAx>
        <c:axId val="1740697264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79507376"/>
        <c:crosses val="autoZero"/>
        <c:crossBetween val="midCat"/>
        <c:majorUnit val="4"/>
      </c:valAx>
      <c:valAx>
        <c:axId val="1779507376"/>
        <c:scaling>
          <c:orientation val="minMax"/>
          <c:max val="70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40697264"/>
        <c:crosses val="autoZero"/>
        <c:crossBetween val="midCat"/>
        <c:majorUnit val="100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9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E$43:$E$49</c:f>
                <c:numCache>
                  <c:formatCode>General</c:formatCode>
                  <c:ptCount val="7"/>
                  <c:pt idx="0">
                    <c:v>55.79</c:v>
                  </c:pt>
                  <c:pt idx="1">
                    <c:v>10.029999999999999</c:v>
                  </c:pt>
                  <c:pt idx="2">
                    <c:v>7.78</c:v>
                  </c:pt>
                  <c:pt idx="3">
                    <c:v>40.06</c:v>
                  </c:pt>
                  <c:pt idx="4">
                    <c:v>33.96</c:v>
                  </c:pt>
                  <c:pt idx="5">
                    <c:v>46.38</c:v>
                  </c:pt>
                  <c:pt idx="6">
                    <c:v>55.79</c:v>
                  </c:pt>
                </c:numCache>
              </c:numRef>
            </c:plus>
            <c:minus>
              <c:numRef>
                <c:f>Sheet2!$E$43:$E$49</c:f>
                <c:numCache>
                  <c:formatCode>General</c:formatCode>
                  <c:ptCount val="7"/>
                  <c:pt idx="0">
                    <c:v>55.79</c:v>
                  </c:pt>
                  <c:pt idx="1">
                    <c:v>10.029999999999999</c:v>
                  </c:pt>
                  <c:pt idx="2">
                    <c:v>7.78</c:v>
                  </c:pt>
                  <c:pt idx="3">
                    <c:v>40.06</c:v>
                  </c:pt>
                  <c:pt idx="4">
                    <c:v>33.96</c:v>
                  </c:pt>
                  <c:pt idx="5">
                    <c:v>46.38</c:v>
                  </c:pt>
                  <c:pt idx="6">
                    <c:v>55.7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2!$B$43:$B$49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C$43:$C$49</c:f>
              <c:numCache>
                <c:formatCode>General</c:formatCode>
                <c:ptCount val="7"/>
                <c:pt idx="0">
                  <c:v>762.16</c:v>
                </c:pt>
                <c:pt idx="1">
                  <c:v>548.05999999999995</c:v>
                </c:pt>
                <c:pt idx="2">
                  <c:v>278.23</c:v>
                </c:pt>
                <c:pt idx="3">
                  <c:v>456.07</c:v>
                </c:pt>
                <c:pt idx="4">
                  <c:v>368.6</c:v>
                </c:pt>
                <c:pt idx="5">
                  <c:v>602.17999999999995</c:v>
                </c:pt>
                <c:pt idx="6">
                  <c:v>762.1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22E-6546-AC38-7F1EB2598C6C}"/>
            </c:ext>
          </c:extLst>
        </c:ser>
        <c:ser>
          <c:idx val="1"/>
          <c:order val="1"/>
          <c:spPr>
            <a:ln w="19050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circle"/>
            <c:size val="9"/>
            <c:spPr>
              <a:solidFill>
                <a:schemeClr val="bg1">
                  <a:lumMod val="75000"/>
                </a:schemeClr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F$43:$F$49</c:f>
                <c:numCache>
                  <c:formatCode>General</c:formatCode>
                  <c:ptCount val="7"/>
                  <c:pt idx="0">
                    <c:v>216.8</c:v>
                  </c:pt>
                  <c:pt idx="1">
                    <c:v>47.27</c:v>
                  </c:pt>
                  <c:pt idx="2">
                    <c:v>4.8499999999999996</c:v>
                  </c:pt>
                  <c:pt idx="3">
                    <c:v>4.93</c:v>
                  </c:pt>
                  <c:pt idx="4">
                    <c:v>127.45</c:v>
                  </c:pt>
                  <c:pt idx="5">
                    <c:v>11.33</c:v>
                  </c:pt>
                  <c:pt idx="6">
                    <c:v>216.8</c:v>
                  </c:pt>
                </c:numCache>
              </c:numRef>
            </c:plus>
            <c:minus>
              <c:numRef>
                <c:f>Sheet2!$F$43:$F$49</c:f>
                <c:numCache>
                  <c:formatCode>General</c:formatCode>
                  <c:ptCount val="7"/>
                  <c:pt idx="0">
                    <c:v>216.8</c:v>
                  </c:pt>
                  <c:pt idx="1">
                    <c:v>47.27</c:v>
                  </c:pt>
                  <c:pt idx="2">
                    <c:v>4.8499999999999996</c:v>
                  </c:pt>
                  <c:pt idx="3">
                    <c:v>4.93</c:v>
                  </c:pt>
                  <c:pt idx="4">
                    <c:v>127.45</c:v>
                  </c:pt>
                  <c:pt idx="5">
                    <c:v>11.33</c:v>
                  </c:pt>
                  <c:pt idx="6">
                    <c:v>216.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2!$B$43:$B$49</c:f>
              <c:numCache>
                <c:formatCode>General</c:formatCode>
                <c:ptCount val="7"/>
                <c:pt idx="0">
                  <c:v>0</c:v>
                </c:pt>
                <c:pt idx="1">
                  <c:v>4</c:v>
                </c:pt>
                <c:pt idx="2">
                  <c:v>8</c:v>
                </c:pt>
                <c:pt idx="3">
                  <c:v>12</c:v>
                </c:pt>
                <c:pt idx="4">
                  <c:v>16</c:v>
                </c:pt>
                <c:pt idx="5">
                  <c:v>20</c:v>
                </c:pt>
                <c:pt idx="6">
                  <c:v>24</c:v>
                </c:pt>
              </c:numCache>
            </c:numRef>
          </c:xVal>
          <c:yVal>
            <c:numRef>
              <c:f>Sheet2!$D$43:$D$49</c:f>
              <c:numCache>
                <c:formatCode>General</c:formatCode>
                <c:ptCount val="7"/>
                <c:pt idx="0">
                  <c:v>797.25</c:v>
                </c:pt>
                <c:pt idx="1">
                  <c:v>507.22</c:v>
                </c:pt>
                <c:pt idx="2">
                  <c:v>216</c:v>
                </c:pt>
                <c:pt idx="3">
                  <c:v>310.88</c:v>
                </c:pt>
                <c:pt idx="4">
                  <c:v>453.91</c:v>
                </c:pt>
                <c:pt idx="5">
                  <c:v>486.09</c:v>
                </c:pt>
                <c:pt idx="6">
                  <c:v>797.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22E-6546-AC38-7F1EB2598C6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40697264"/>
        <c:axId val="1779507376"/>
      </c:scatterChart>
      <c:valAx>
        <c:axId val="1740697264"/>
        <c:scaling>
          <c:orientation val="minMax"/>
          <c:max val="24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79507376"/>
        <c:crosses val="autoZero"/>
        <c:crossBetween val="midCat"/>
        <c:majorUnit val="4"/>
      </c:valAx>
      <c:valAx>
        <c:axId val="17795073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40697264"/>
        <c:crosses val="autoZero"/>
        <c:crossBetween val="midCat"/>
        <c:majorUnit val="20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D$6:$D$12</c:f>
                <c:numCache>
                  <c:formatCode>General</c:formatCode>
                  <c:ptCount val="7"/>
                  <c:pt idx="0">
                    <c:v>114.61</c:v>
                  </c:pt>
                  <c:pt idx="1">
                    <c:v>16.12</c:v>
                  </c:pt>
                  <c:pt idx="2">
                    <c:v>273.77</c:v>
                  </c:pt>
                  <c:pt idx="3">
                    <c:v>294.64999999999998</c:v>
                  </c:pt>
                  <c:pt idx="4">
                    <c:v>41.61</c:v>
                  </c:pt>
                  <c:pt idx="5">
                    <c:v>194.64</c:v>
                  </c:pt>
                  <c:pt idx="6">
                    <c:v>74.09</c:v>
                  </c:pt>
                </c:numCache>
              </c:numRef>
            </c:plus>
            <c:minus>
              <c:numRef>
                <c:f>Sheet2!$D$6:$D$12</c:f>
                <c:numCache>
                  <c:formatCode>General</c:formatCode>
                  <c:ptCount val="7"/>
                  <c:pt idx="0">
                    <c:v>114.61</c:v>
                  </c:pt>
                  <c:pt idx="1">
                    <c:v>16.12</c:v>
                  </c:pt>
                  <c:pt idx="2">
                    <c:v>273.77</c:v>
                  </c:pt>
                  <c:pt idx="3">
                    <c:v>294.64999999999998</c:v>
                  </c:pt>
                  <c:pt idx="4">
                    <c:v>41.61</c:v>
                  </c:pt>
                  <c:pt idx="5">
                    <c:v>194.64</c:v>
                  </c:pt>
                  <c:pt idx="6">
                    <c:v>74.09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2!$B$6:$B$12</c:f>
              <c:numCache>
                <c:formatCode>General</c:formatCode>
                <c:ptCount val="7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3</c:v>
                </c:pt>
                <c:pt idx="4">
                  <c:v>6</c:v>
                </c:pt>
                <c:pt idx="5">
                  <c:v>12</c:v>
                </c:pt>
                <c:pt idx="6">
                  <c:v>24</c:v>
                </c:pt>
              </c:numCache>
            </c:numRef>
          </c:xVal>
          <c:yVal>
            <c:numRef>
              <c:f>Sheet2!$C$6:$C$12</c:f>
              <c:numCache>
                <c:formatCode>General</c:formatCode>
                <c:ptCount val="7"/>
                <c:pt idx="0">
                  <c:v>883.01</c:v>
                </c:pt>
                <c:pt idx="1">
                  <c:v>1026.6099999999999</c:v>
                </c:pt>
                <c:pt idx="2">
                  <c:v>1314.54</c:v>
                </c:pt>
                <c:pt idx="3">
                  <c:v>2916.26</c:v>
                </c:pt>
                <c:pt idx="4">
                  <c:v>5182</c:v>
                </c:pt>
                <c:pt idx="5">
                  <c:v>6182.81</c:v>
                </c:pt>
                <c:pt idx="6">
                  <c:v>7216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3C5-D746-A3BB-5482D49B7E0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90111440"/>
        <c:axId val="990113120"/>
      </c:scatterChart>
      <c:valAx>
        <c:axId val="990111440"/>
        <c:scaling>
          <c:orientation val="minMax"/>
          <c:max val="25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90113120"/>
        <c:crosses val="autoZero"/>
        <c:crossBetween val="midCat"/>
        <c:majorUnit val="6"/>
      </c:valAx>
      <c:valAx>
        <c:axId val="9901131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90111440"/>
        <c:crosses val="autoZero"/>
        <c:crossBetween val="midCat"/>
        <c:majorUnit val="200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10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D$25:$D$31</c:f>
                <c:numCache>
                  <c:formatCode>General</c:formatCode>
                  <c:ptCount val="7"/>
                  <c:pt idx="0">
                    <c:v>38.42</c:v>
                  </c:pt>
                  <c:pt idx="1">
                    <c:v>27.59</c:v>
                  </c:pt>
                  <c:pt idx="2">
                    <c:v>1.03</c:v>
                  </c:pt>
                  <c:pt idx="3">
                    <c:v>35.270000000000003</c:v>
                  </c:pt>
                  <c:pt idx="4">
                    <c:v>68.19</c:v>
                  </c:pt>
                  <c:pt idx="5">
                    <c:v>85.5</c:v>
                  </c:pt>
                  <c:pt idx="6">
                    <c:v>483.15</c:v>
                  </c:pt>
                </c:numCache>
              </c:numRef>
            </c:plus>
            <c:minus>
              <c:numRef>
                <c:f>Sheet2!$D$25:$D$31</c:f>
                <c:numCache>
                  <c:formatCode>General</c:formatCode>
                  <c:ptCount val="7"/>
                  <c:pt idx="0">
                    <c:v>38.42</c:v>
                  </c:pt>
                  <c:pt idx="1">
                    <c:v>27.59</c:v>
                  </c:pt>
                  <c:pt idx="2">
                    <c:v>1.03</c:v>
                  </c:pt>
                  <c:pt idx="3">
                    <c:v>35.270000000000003</c:v>
                  </c:pt>
                  <c:pt idx="4">
                    <c:v>68.19</c:v>
                  </c:pt>
                  <c:pt idx="5">
                    <c:v>85.5</c:v>
                  </c:pt>
                  <c:pt idx="6">
                    <c:v>483.15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2!$B$25:$B$31</c:f>
              <c:numCache>
                <c:formatCode>General</c:formatCode>
                <c:ptCount val="7"/>
                <c:pt idx="0">
                  <c:v>0</c:v>
                </c:pt>
                <c:pt idx="1">
                  <c:v>0.5</c:v>
                </c:pt>
                <c:pt idx="2">
                  <c:v>1</c:v>
                </c:pt>
                <c:pt idx="3">
                  <c:v>3</c:v>
                </c:pt>
                <c:pt idx="4">
                  <c:v>6</c:v>
                </c:pt>
                <c:pt idx="5">
                  <c:v>12</c:v>
                </c:pt>
                <c:pt idx="6">
                  <c:v>24</c:v>
                </c:pt>
              </c:numCache>
            </c:numRef>
          </c:xVal>
          <c:yVal>
            <c:numRef>
              <c:f>Sheet2!$C$25:$C$31</c:f>
              <c:numCache>
                <c:formatCode>General</c:formatCode>
                <c:ptCount val="7"/>
                <c:pt idx="0">
                  <c:v>307.02</c:v>
                </c:pt>
                <c:pt idx="1">
                  <c:v>291.24</c:v>
                </c:pt>
                <c:pt idx="2">
                  <c:v>296.83999999999997</c:v>
                </c:pt>
                <c:pt idx="3">
                  <c:v>1397.01</c:v>
                </c:pt>
                <c:pt idx="4">
                  <c:v>919.83</c:v>
                </c:pt>
                <c:pt idx="5">
                  <c:v>1576.33</c:v>
                </c:pt>
                <c:pt idx="6">
                  <c:v>2348.4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A13-A849-A378-5F629D8D52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90111440"/>
        <c:axId val="990113120"/>
      </c:scatterChart>
      <c:valAx>
        <c:axId val="990111440"/>
        <c:scaling>
          <c:orientation val="minMax"/>
          <c:max val="25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90113120"/>
        <c:crosses val="autoZero"/>
        <c:crossBetween val="midCat"/>
        <c:majorUnit val="6"/>
      </c:valAx>
      <c:valAx>
        <c:axId val="990113120"/>
        <c:scaling>
          <c:orientation val="minMax"/>
          <c:max val="300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90111440"/>
        <c:crosses val="autoZero"/>
        <c:crossBetween val="midCat"/>
        <c:majorUnit val="50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4267A21-9B34-2A45-81D4-FE25AD58BB9C}" type="datetimeFigureOut">
              <a:rPr lang="en-US" smtClean="0"/>
              <a:t>9/8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426F21-0A61-394B-9B99-5AD5CAC42D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32264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426F21-0A61-394B-9B99-5AD5CAC42DC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5733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DE3EB-2B9E-2F4E-80F3-CB5AE9AE6607}" type="datetimeFigureOut">
              <a:rPr lang="en-US" smtClean="0"/>
              <a:t>9/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34CE3-7EAF-7E46-9140-C1307530C0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60986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DE3EB-2B9E-2F4E-80F3-CB5AE9AE6607}" type="datetimeFigureOut">
              <a:rPr lang="en-US" smtClean="0"/>
              <a:t>9/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34CE3-7EAF-7E46-9140-C1307530C0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3173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DE3EB-2B9E-2F4E-80F3-CB5AE9AE6607}" type="datetimeFigureOut">
              <a:rPr lang="en-US" smtClean="0"/>
              <a:t>9/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34CE3-7EAF-7E46-9140-C1307530C0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50350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DE3EB-2B9E-2F4E-80F3-CB5AE9AE6607}" type="datetimeFigureOut">
              <a:rPr lang="en-US" smtClean="0"/>
              <a:t>9/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34CE3-7EAF-7E46-9140-C1307530C0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08839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DE3EB-2B9E-2F4E-80F3-CB5AE9AE6607}" type="datetimeFigureOut">
              <a:rPr lang="en-US" smtClean="0"/>
              <a:t>9/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34CE3-7EAF-7E46-9140-C1307530C0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82794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DE3EB-2B9E-2F4E-80F3-CB5AE9AE6607}" type="datetimeFigureOut">
              <a:rPr lang="en-US" smtClean="0"/>
              <a:t>9/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34CE3-7EAF-7E46-9140-C1307530C0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22024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DE3EB-2B9E-2F4E-80F3-CB5AE9AE6607}" type="datetimeFigureOut">
              <a:rPr lang="en-US" smtClean="0"/>
              <a:t>9/8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34CE3-7EAF-7E46-9140-C1307530C0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4119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DE3EB-2B9E-2F4E-80F3-CB5AE9AE6607}" type="datetimeFigureOut">
              <a:rPr lang="en-US" smtClean="0"/>
              <a:t>9/8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34CE3-7EAF-7E46-9140-C1307530C0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47252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DE3EB-2B9E-2F4E-80F3-CB5AE9AE6607}" type="datetimeFigureOut">
              <a:rPr lang="en-US" smtClean="0"/>
              <a:t>9/8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34CE3-7EAF-7E46-9140-C1307530C0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26710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DE3EB-2B9E-2F4E-80F3-CB5AE9AE6607}" type="datetimeFigureOut">
              <a:rPr lang="en-US" smtClean="0"/>
              <a:t>9/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34CE3-7EAF-7E46-9140-C1307530C0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78742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DE3EB-2B9E-2F4E-80F3-CB5AE9AE6607}" type="datetimeFigureOut">
              <a:rPr lang="en-US" smtClean="0"/>
              <a:t>9/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34CE3-7EAF-7E46-9140-C1307530C0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5683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1DE3EB-2B9E-2F4E-80F3-CB5AE9AE6607}" type="datetimeFigureOut">
              <a:rPr lang="en-US" smtClean="0"/>
              <a:t>9/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334CE3-7EAF-7E46-9140-C1307530C0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18376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6965DD65-5BBD-E842-9765-768F0035ED38}"/>
              </a:ext>
            </a:extLst>
          </p:cNvPr>
          <p:cNvSpPr/>
          <p:nvPr/>
        </p:nvSpPr>
        <p:spPr>
          <a:xfrm>
            <a:off x="1492412" y="6105709"/>
            <a:ext cx="426164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Figure S1</a:t>
            </a:r>
            <a:r>
              <a:rPr lang="en-US" sz="1200" dirty="0"/>
              <a:t>. Native, starch-containing polyacrylamide gel stained with iodine illustrating the starch hydrolases in leaf extracts from WT and a T-DNA mutant (SALK_004259) in the </a:t>
            </a:r>
            <a:r>
              <a:rPr lang="en-US" sz="1200" i="1" dirty="0"/>
              <a:t>BAM5</a:t>
            </a:r>
            <a:r>
              <a:rPr lang="en-US" sz="1200" dirty="0"/>
              <a:t> gene. The BAM5 enzyme was previously named “A3” (Lin et al., 1988; Monroe et al., 1990).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56F03DF0-6B04-D14A-B083-C4463F0D8C50}"/>
              </a:ext>
            </a:extLst>
          </p:cNvPr>
          <p:cNvGrpSpPr/>
          <p:nvPr/>
        </p:nvGrpSpPr>
        <p:grpSpPr>
          <a:xfrm>
            <a:off x="1742325" y="1588731"/>
            <a:ext cx="2484743" cy="3740451"/>
            <a:chOff x="1742325" y="1588731"/>
            <a:chExt cx="2484743" cy="3740451"/>
          </a:xfrm>
        </p:grpSpPr>
        <p:pic>
          <p:nvPicPr>
            <p:cNvPr id="4" name="Picture 6" descr="bam5-3">
              <a:extLst>
                <a:ext uri="{FF2B5EF4-FFF2-40B4-BE49-F238E27FC236}">
                  <a16:creationId xmlns:a16="http://schemas.microsoft.com/office/drawing/2014/main" id="{A81DDE99-BA2B-AD48-BE56-DBFEA019E67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>
                      <a14:imgEffect>
                        <a14:brightnessContrast bright="-18000" contrast="2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98869" y="1963682"/>
              <a:ext cx="1528199" cy="3365500"/>
            </a:xfrm>
            <a:prstGeom prst="rect">
              <a:avLst/>
            </a:prstGeom>
            <a:noFill/>
            <a:ln w="3810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76DAEC1B-4725-4742-9465-06DD1C48D4FB}"/>
                </a:ext>
              </a:extLst>
            </p:cNvPr>
            <p:cNvSpPr txBox="1"/>
            <p:nvPr/>
          </p:nvSpPr>
          <p:spPr>
            <a:xfrm>
              <a:off x="2866991" y="1588731"/>
              <a:ext cx="13308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WT        </a:t>
              </a:r>
              <a:r>
                <a:rPr lang="en-US" sz="1600" b="1" i="1" dirty="0"/>
                <a:t>bam5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4AB59D2-391A-EB43-98F7-2E69862672D0}"/>
                </a:ext>
              </a:extLst>
            </p:cNvPr>
            <p:cNvSpPr txBox="1"/>
            <p:nvPr/>
          </p:nvSpPr>
          <p:spPr>
            <a:xfrm>
              <a:off x="1742325" y="4302301"/>
              <a:ext cx="70686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BAM5</a:t>
              </a:r>
            </a:p>
          </p:txBody>
        </p:sp>
        <p:cxnSp>
          <p:nvCxnSpPr>
            <p:cNvPr id="3" name="Straight Arrow Connector 2">
              <a:extLst>
                <a:ext uri="{FF2B5EF4-FFF2-40B4-BE49-F238E27FC236}">
                  <a16:creationId xmlns:a16="http://schemas.microsoft.com/office/drawing/2014/main" id="{C4992B7E-BCCF-294E-9A08-E4AEF3330771}"/>
                </a:ext>
              </a:extLst>
            </p:cNvPr>
            <p:cNvCxnSpPr>
              <a:cxnSpLocks/>
            </p:cNvCxnSpPr>
            <p:nvPr/>
          </p:nvCxnSpPr>
          <p:spPr>
            <a:xfrm>
              <a:off x="2434315" y="4481914"/>
              <a:ext cx="226114" cy="0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1501407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C94C8D7A-7635-B646-9EFF-4236321C42D1}"/>
              </a:ext>
            </a:extLst>
          </p:cNvPr>
          <p:cNvGrpSpPr/>
          <p:nvPr/>
        </p:nvGrpSpPr>
        <p:grpSpPr>
          <a:xfrm>
            <a:off x="1085653" y="1247941"/>
            <a:ext cx="4348996" cy="5291030"/>
            <a:chOff x="1085653" y="1247941"/>
            <a:chExt cx="4348996" cy="5291030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278FD16B-CABA-654A-951F-C14D227D8DC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>
                      <a14:imgEffect>
                        <a14:brightnessContrast bright="40000" contrast="-20000"/>
                      </a14:imgEffect>
                    </a14:imgLayer>
                  </a14:imgProps>
                </a:ext>
              </a:extLst>
            </a:blip>
            <a:srcRect l="64599" t="25878" r="22768" b="20302"/>
            <a:stretch/>
          </p:blipFill>
          <p:spPr>
            <a:xfrm rot="5400000">
              <a:off x="3046472" y="4620604"/>
              <a:ext cx="917585" cy="2919149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2E7221F8-2A87-AA4F-B6C6-522E1E442FEE}"/>
                </a:ext>
              </a:extLst>
            </p:cNvPr>
            <p:cNvSpPr txBox="1"/>
            <p:nvPr/>
          </p:nvSpPr>
          <p:spPr>
            <a:xfrm>
              <a:off x="1698268" y="1247941"/>
              <a:ext cx="325121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err="1"/>
                <a:t>kbp</a:t>
              </a:r>
              <a:r>
                <a:rPr lang="en-US" sz="1000" b="1" dirty="0"/>
                <a:t>        M       WT   </a:t>
              </a:r>
              <a:r>
                <a:rPr lang="en-US" sz="1000" b="1" i="1" dirty="0"/>
                <a:t>B-Null</a:t>
              </a:r>
              <a:r>
                <a:rPr lang="en-US" sz="1000" b="1" dirty="0"/>
                <a:t>  </a:t>
              </a:r>
              <a:r>
                <a:rPr lang="en-US" sz="1000" b="1" i="1" dirty="0"/>
                <a:t>B1-Q   B2-Q   B3-Q   B5-Q   B6-Q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E6769201-5536-694D-801B-850C94D46A57}"/>
                </a:ext>
              </a:extLst>
            </p:cNvPr>
            <p:cNvSpPr txBox="1"/>
            <p:nvPr/>
          </p:nvSpPr>
          <p:spPr>
            <a:xfrm>
              <a:off x="4948619" y="1769051"/>
              <a:ext cx="48603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WT</a:t>
              </a:r>
            </a:p>
            <a:p>
              <a:endParaRPr lang="en-US" sz="1600" b="1" dirty="0"/>
            </a:p>
            <a:p>
              <a:r>
                <a:rPr lang="en-US" sz="1000" b="1" i="1" dirty="0"/>
                <a:t>bam1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9274690-1993-DA4B-9F29-E3BADF8C5456}"/>
                </a:ext>
              </a:extLst>
            </p:cNvPr>
            <p:cNvSpPr txBox="1"/>
            <p:nvPr/>
          </p:nvSpPr>
          <p:spPr>
            <a:xfrm>
              <a:off x="4948619" y="2759393"/>
              <a:ext cx="48603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WT</a:t>
              </a:r>
            </a:p>
            <a:p>
              <a:endParaRPr lang="en-US" sz="1600" b="1" dirty="0"/>
            </a:p>
            <a:p>
              <a:r>
                <a:rPr lang="en-US" sz="1000" b="1" i="1" dirty="0"/>
                <a:t>bam2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536C93B-5CD8-5D45-8FA3-4A92DDFEAF71}"/>
                </a:ext>
              </a:extLst>
            </p:cNvPr>
            <p:cNvSpPr txBox="1"/>
            <p:nvPr/>
          </p:nvSpPr>
          <p:spPr>
            <a:xfrm>
              <a:off x="4948619" y="4735739"/>
              <a:ext cx="486030" cy="6617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WT</a:t>
              </a:r>
            </a:p>
            <a:p>
              <a:endParaRPr lang="en-US" sz="700" b="1" dirty="0"/>
            </a:p>
            <a:p>
              <a:r>
                <a:rPr lang="en-US" sz="1000" b="1" i="1" dirty="0"/>
                <a:t>bam5</a:t>
              </a:r>
            </a:p>
            <a:p>
              <a:r>
                <a:rPr lang="en-US" sz="1000" b="1" i="1" dirty="0"/>
                <a:t>bam5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BC82FB3-1559-DA4D-872C-06BE857D16D6}"/>
                </a:ext>
              </a:extLst>
            </p:cNvPr>
            <p:cNvSpPr txBox="1"/>
            <p:nvPr/>
          </p:nvSpPr>
          <p:spPr>
            <a:xfrm>
              <a:off x="4948619" y="5733385"/>
              <a:ext cx="48603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WT</a:t>
              </a:r>
            </a:p>
            <a:p>
              <a:endParaRPr lang="en-US" sz="600" b="1" dirty="0"/>
            </a:p>
            <a:p>
              <a:r>
                <a:rPr lang="en-US" sz="1000" b="1" i="1" dirty="0"/>
                <a:t>bam6</a:t>
              </a:r>
            </a:p>
            <a:p>
              <a:r>
                <a:rPr lang="en-US" sz="1000" b="1" i="1" dirty="0"/>
                <a:t>bam6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D77B517-0B46-4F4E-B25D-4FE3F8D18BC0}"/>
                </a:ext>
              </a:extLst>
            </p:cNvPr>
            <p:cNvSpPr txBox="1"/>
            <p:nvPr/>
          </p:nvSpPr>
          <p:spPr>
            <a:xfrm>
              <a:off x="1721216" y="1575507"/>
              <a:ext cx="349839" cy="4462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b="1" dirty="0"/>
                <a:t>1.5</a:t>
              </a:r>
            </a:p>
            <a:p>
              <a:pPr algn="r"/>
              <a:endParaRPr lang="en-US" sz="300" b="1" dirty="0"/>
            </a:p>
            <a:p>
              <a:pPr algn="r"/>
              <a:r>
                <a:rPr lang="en-US" sz="1000" b="1" dirty="0"/>
                <a:t>1.0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51680403-C64A-384C-A26F-237E56F88294}"/>
                </a:ext>
              </a:extLst>
            </p:cNvPr>
            <p:cNvSpPr txBox="1"/>
            <p:nvPr/>
          </p:nvSpPr>
          <p:spPr>
            <a:xfrm>
              <a:off x="1721216" y="2687464"/>
              <a:ext cx="349839" cy="4462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b="1" dirty="0"/>
                <a:t>1.5</a:t>
              </a:r>
            </a:p>
            <a:p>
              <a:pPr algn="r"/>
              <a:endParaRPr lang="en-US" sz="300" b="1" dirty="0"/>
            </a:p>
            <a:p>
              <a:pPr algn="r"/>
              <a:r>
                <a:rPr lang="en-US" sz="1000" b="1" dirty="0"/>
                <a:t>1.0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6BF22122-FCA2-1C48-AF61-E3436294A4DB}"/>
                </a:ext>
              </a:extLst>
            </p:cNvPr>
            <p:cNvSpPr txBox="1"/>
            <p:nvPr/>
          </p:nvSpPr>
          <p:spPr>
            <a:xfrm>
              <a:off x="1721279" y="3620522"/>
              <a:ext cx="34977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b="1" dirty="0"/>
                <a:t>1.0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9A07B4D-52A4-7847-A182-4AE5FD5E382A}"/>
                </a:ext>
              </a:extLst>
            </p:cNvPr>
            <p:cNvSpPr txBox="1"/>
            <p:nvPr/>
          </p:nvSpPr>
          <p:spPr>
            <a:xfrm>
              <a:off x="1721216" y="4618831"/>
              <a:ext cx="349839" cy="4462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b="1" dirty="0"/>
                <a:t>1.5</a:t>
              </a:r>
            </a:p>
            <a:p>
              <a:pPr algn="r"/>
              <a:endParaRPr lang="en-US" sz="300" b="1" dirty="0"/>
            </a:p>
            <a:p>
              <a:pPr algn="r"/>
              <a:r>
                <a:rPr lang="en-US" sz="1000" b="1" dirty="0"/>
                <a:t>1.0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B0C3452-1B18-5742-A9E7-3B47E26F2C4B}"/>
                </a:ext>
              </a:extLst>
            </p:cNvPr>
            <p:cNvSpPr txBox="1"/>
            <p:nvPr/>
          </p:nvSpPr>
          <p:spPr>
            <a:xfrm>
              <a:off x="1721216" y="5583752"/>
              <a:ext cx="349839" cy="4462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b="1" dirty="0"/>
                <a:t>1.5</a:t>
              </a:r>
            </a:p>
            <a:p>
              <a:pPr algn="r"/>
              <a:endParaRPr lang="en-US" sz="300" b="1" dirty="0"/>
            </a:p>
            <a:p>
              <a:pPr algn="r"/>
              <a:r>
                <a:rPr lang="en-US" sz="1000" b="1" dirty="0"/>
                <a:t>1.0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AAF091C6-80F4-3D4F-AC6D-10EBD9260EC2}"/>
                </a:ext>
              </a:extLst>
            </p:cNvPr>
            <p:cNvSpPr txBox="1"/>
            <p:nvPr/>
          </p:nvSpPr>
          <p:spPr>
            <a:xfrm>
              <a:off x="4948619" y="3784847"/>
              <a:ext cx="486030" cy="6924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i="1" dirty="0"/>
                <a:t>bam3</a:t>
              </a:r>
            </a:p>
            <a:p>
              <a:endParaRPr lang="en-US" sz="400" b="1" dirty="0"/>
            </a:p>
            <a:p>
              <a:r>
                <a:rPr lang="en-US" sz="1000" b="1" dirty="0"/>
                <a:t>WT</a:t>
              </a:r>
            </a:p>
            <a:p>
              <a:endParaRPr lang="en-US" sz="500" b="1" dirty="0"/>
            </a:p>
            <a:p>
              <a:r>
                <a:rPr lang="en-US" sz="1000" b="1" dirty="0"/>
                <a:t>WT</a:t>
              </a:r>
            </a:p>
          </p:txBody>
        </p: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CAB55247-C15C-2040-B177-CF0587E378D4}"/>
                </a:ext>
              </a:extLst>
            </p:cNvPr>
            <p:cNvGrpSpPr/>
            <p:nvPr/>
          </p:nvGrpSpPr>
          <p:grpSpPr>
            <a:xfrm>
              <a:off x="2045693" y="4614499"/>
              <a:ext cx="2915775" cy="997993"/>
              <a:chOff x="2570625" y="4850981"/>
              <a:chExt cx="2915775" cy="997993"/>
            </a:xfrm>
          </p:grpSpPr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AA718BFA-2A03-F94C-9463-BBCBC28BFA3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>
                        <a14:imgEffect>
                          <a14:brightnessContrast bright="40000" contrast="-20000"/>
                        </a14:imgEffect>
                      </a14:imgLayer>
                    </a14:imgProps>
                  </a:ext>
                </a:extLst>
              </a:blip>
              <a:srcRect l="25016" t="25708" r="61229" b="20472"/>
              <a:stretch/>
            </p:blipFill>
            <p:spPr>
              <a:xfrm rot="5400000">
                <a:off x="3529516" y="3892090"/>
                <a:ext cx="997993" cy="2915775"/>
              </a:xfrm>
              <a:prstGeom prst="rect">
                <a:avLst/>
              </a:prstGeom>
              <a:ln w="28575">
                <a:solidFill>
                  <a:schemeClr val="tx1"/>
                </a:solidFill>
              </a:ln>
            </p:spPr>
          </p:pic>
          <p:sp>
            <p:nvSpPr>
              <p:cNvPr id="18" name="Oval 17">
                <a:extLst>
                  <a:ext uri="{FF2B5EF4-FFF2-40B4-BE49-F238E27FC236}">
                    <a16:creationId xmlns:a16="http://schemas.microsoft.com/office/drawing/2014/main" id="{4D678899-3448-464A-B8AC-BA4466A6899F}"/>
                  </a:ext>
                </a:extLst>
              </p:cNvPr>
              <p:cNvSpPr/>
              <p:nvPr/>
            </p:nvSpPr>
            <p:spPr>
              <a:xfrm>
                <a:off x="4771769" y="5100531"/>
                <a:ext cx="45719" cy="45719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" name="Oval 18">
                <a:extLst>
                  <a:ext uri="{FF2B5EF4-FFF2-40B4-BE49-F238E27FC236}">
                    <a16:creationId xmlns:a16="http://schemas.microsoft.com/office/drawing/2014/main" id="{74E960BC-295C-A04B-AA45-EC94B315D958}"/>
                  </a:ext>
                </a:extLst>
              </p:cNvPr>
              <p:cNvSpPr/>
              <p:nvPr/>
            </p:nvSpPr>
            <p:spPr>
              <a:xfrm>
                <a:off x="4935695" y="5091567"/>
                <a:ext cx="45719" cy="45719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" name="Oval 19">
                <a:extLst>
                  <a:ext uri="{FF2B5EF4-FFF2-40B4-BE49-F238E27FC236}">
                    <a16:creationId xmlns:a16="http://schemas.microsoft.com/office/drawing/2014/main" id="{10F81CF9-36CC-ED4B-8E67-808DE8288D17}"/>
                  </a:ext>
                </a:extLst>
              </p:cNvPr>
              <p:cNvSpPr/>
              <p:nvPr/>
            </p:nvSpPr>
            <p:spPr>
              <a:xfrm>
                <a:off x="3003160" y="5183775"/>
                <a:ext cx="45719" cy="45719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7AE9D441-2E59-8E45-9A59-366C97EFF40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>
                      <a14:imgEffect>
                        <a14:brightnessContrast bright="40000" contrast="-20000"/>
                      </a14:imgEffect>
                    </a14:imgLayer>
                  </a14:imgProps>
                </a:ext>
              </a:extLst>
            </a:blip>
            <a:srcRect l="37604" t="24617" r="45808" b="23896"/>
            <a:stretch/>
          </p:blipFill>
          <p:spPr>
            <a:xfrm rot="5400000">
              <a:off x="3021265" y="2637465"/>
              <a:ext cx="963785" cy="2914928"/>
            </a:xfrm>
            <a:prstGeom prst="rect">
              <a:avLst/>
            </a:prstGeom>
            <a:ln w="28575">
              <a:solidFill>
                <a:schemeClr val="tx1"/>
              </a:solidFill>
            </a:ln>
          </p:spPr>
        </p:pic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F7BAE4D6-CAE4-374D-A530-007F7588AD53}"/>
                </a:ext>
              </a:extLst>
            </p:cNvPr>
            <p:cNvSpPr/>
            <p:nvPr/>
          </p:nvSpPr>
          <p:spPr>
            <a:xfrm>
              <a:off x="1085653" y="2668034"/>
              <a:ext cx="64139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/>
                <a:t>BAM2</a:t>
              </a:r>
              <a:endParaRPr lang="en-US" sz="1400" dirty="0"/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15A75F32-03E7-414F-A485-1AC4001C4695}"/>
                </a:ext>
              </a:extLst>
            </p:cNvPr>
            <p:cNvSpPr/>
            <p:nvPr/>
          </p:nvSpPr>
          <p:spPr>
            <a:xfrm>
              <a:off x="1085653" y="3594361"/>
              <a:ext cx="64139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/>
                <a:t>BAM3</a:t>
              </a:r>
              <a:endParaRPr lang="en-US" sz="1400" dirty="0"/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2CA870D3-6645-684B-95C2-D79C7BCCED7E}"/>
                </a:ext>
              </a:extLst>
            </p:cNvPr>
            <p:cNvSpPr/>
            <p:nvPr/>
          </p:nvSpPr>
          <p:spPr>
            <a:xfrm>
              <a:off x="1085653" y="4604372"/>
              <a:ext cx="64139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/>
                <a:t>BAM5</a:t>
              </a:r>
              <a:endParaRPr lang="en-US" sz="1400" dirty="0"/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92DFFBAA-136B-D149-8DB4-12CEFA022B20}"/>
                </a:ext>
              </a:extLst>
            </p:cNvPr>
            <p:cNvSpPr/>
            <p:nvPr/>
          </p:nvSpPr>
          <p:spPr>
            <a:xfrm>
              <a:off x="1085653" y="5591195"/>
              <a:ext cx="64139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/>
                <a:t>BAM6</a:t>
              </a:r>
              <a:endParaRPr lang="en-US" sz="1400" dirty="0"/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8336BD11-4341-C64E-AC29-2CC5F8246DAF}"/>
                </a:ext>
              </a:extLst>
            </p:cNvPr>
            <p:cNvSpPr/>
            <p:nvPr/>
          </p:nvSpPr>
          <p:spPr>
            <a:xfrm>
              <a:off x="1085653" y="1484971"/>
              <a:ext cx="64139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/>
                <a:t>BAM1</a:t>
              </a:r>
              <a:endParaRPr lang="en-US" sz="1400" dirty="0"/>
            </a:p>
          </p:txBody>
        </p:sp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B5049474-9127-A446-856F-E9300F705615}"/>
                </a:ext>
              </a:extLst>
            </p:cNvPr>
            <p:cNvGrpSpPr/>
            <p:nvPr/>
          </p:nvGrpSpPr>
          <p:grpSpPr>
            <a:xfrm>
              <a:off x="2045694" y="2667144"/>
              <a:ext cx="2916049" cy="936980"/>
              <a:chOff x="2570626" y="2903626"/>
              <a:chExt cx="2916049" cy="936980"/>
            </a:xfrm>
          </p:grpSpPr>
          <p:pic>
            <p:nvPicPr>
              <p:cNvPr id="28" name="Picture 27">
                <a:extLst>
                  <a:ext uri="{FF2B5EF4-FFF2-40B4-BE49-F238E27FC236}">
                    <a16:creationId xmlns:a16="http://schemas.microsoft.com/office/drawing/2014/main" id="{DEF78C31-50AF-4143-8537-600C2A23DE9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>
                        <a14:imgEffect>
                          <a14:brightnessContrast bright="40000" contrast="-20000"/>
                        </a14:imgEffect>
                      </a14:imgLayer>
                    </a14:imgProps>
                  </a:ext>
                </a:extLst>
              </a:blip>
              <a:srcRect l="60855" t="22046" r="26232" b="24134"/>
              <a:stretch/>
            </p:blipFill>
            <p:spPr>
              <a:xfrm rot="5400000">
                <a:off x="3560161" y="1914091"/>
                <a:ext cx="936980" cy="2916049"/>
              </a:xfrm>
              <a:prstGeom prst="rect">
                <a:avLst/>
              </a:prstGeom>
              <a:ln w="28575">
                <a:solidFill>
                  <a:schemeClr val="tx1"/>
                </a:solidFill>
              </a:ln>
            </p:spPr>
          </p:pic>
          <p:sp>
            <p:nvSpPr>
              <p:cNvPr id="29" name="Oval 28">
                <a:extLst>
                  <a:ext uri="{FF2B5EF4-FFF2-40B4-BE49-F238E27FC236}">
                    <a16:creationId xmlns:a16="http://schemas.microsoft.com/office/drawing/2014/main" id="{81DCE604-B3C7-2442-8E98-71E25EE1B314}"/>
                  </a:ext>
                </a:extLst>
              </p:cNvPr>
              <p:cNvSpPr/>
              <p:nvPr/>
            </p:nvSpPr>
            <p:spPr>
              <a:xfrm>
                <a:off x="4085342" y="3129414"/>
                <a:ext cx="45719" cy="45719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0" name="Oval 29">
                <a:extLst>
                  <a:ext uri="{FF2B5EF4-FFF2-40B4-BE49-F238E27FC236}">
                    <a16:creationId xmlns:a16="http://schemas.microsoft.com/office/drawing/2014/main" id="{682C26C3-EA23-A840-A344-779ED7CCF8AD}"/>
                  </a:ext>
                </a:extLst>
              </p:cNvPr>
              <p:cNvSpPr/>
              <p:nvPr/>
            </p:nvSpPr>
            <p:spPr>
              <a:xfrm>
                <a:off x="4231392" y="3124324"/>
                <a:ext cx="45719" cy="45719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66703697-5537-2446-AFE9-2C37851334FB}"/>
                </a:ext>
              </a:extLst>
            </p:cNvPr>
            <p:cNvGrpSpPr/>
            <p:nvPr/>
          </p:nvGrpSpPr>
          <p:grpSpPr>
            <a:xfrm>
              <a:off x="2045693" y="1577204"/>
              <a:ext cx="2916741" cy="1085990"/>
              <a:chOff x="2570625" y="1813686"/>
              <a:chExt cx="2916741" cy="1085990"/>
            </a:xfrm>
          </p:grpSpPr>
          <p:pic>
            <p:nvPicPr>
              <p:cNvPr id="32" name="Picture 31">
                <a:extLst>
                  <a:ext uri="{FF2B5EF4-FFF2-40B4-BE49-F238E27FC236}">
                    <a16:creationId xmlns:a16="http://schemas.microsoft.com/office/drawing/2014/main" id="{62F05CF5-882C-C744-8B24-296B2DD9DC6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>
                        <a14:imgEffect>
                          <a14:brightnessContrast bright="40000" contrast="-20000"/>
                        </a14:imgEffect>
                      </a14:imgLayer>
                    </a14:imgProps>
                  </a:ext>
                </a:extLst>
              </a:blip>
              <a:srcRect l="21749" t="22046" r="63287" b="24134"/>
              <a:stretch/>
            </p:blipFill>
            <p:spPr>
              <a:xfrm rot="5400000">
                <a:off x="3486001" y="898310"/>
                <a:ext cx="1085990" cy="2916741"/>
              </a:xfrm>
              <a:prstGeom prst="rect">
                <a:avLst/>
              </a:prstGeom>
              <a:ln w="28575">
                <a:solidFill>
                  <a:schemeClr val="tx1"/>
                </a:solidFill>
              </a:ln>
            </p:spPr>
          </p:pic>
          <p:sp>
            <p:nvSpPr>
              <p:cNvPr id="33" name="Oval 32">
                <a:extLst>
                  <a:ext uri="{FF2B5EF4-FFF2-40B4-BE49-F238E27FC236}">
                    <a16:creationId xmlns:a16="http://schemas.microsoft.com/office/drawing/2014/main" id="{D46F64C6-BBA1-6942-9CFF-8137F80F026D}"/>
                  </a:ext>
                </a:extLst>
              </p:cNvPr>
              <p:cNvSpPr/>
              <p:nvPr/>
            </p:nvSpPr>
            <p:spPr>
              <a:xfrm>
                <a:off x="3729742" y="2108324"/>
                <a:ext cx="45719" cy="45719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BCA9FD76-12D4-BB41-B036-B80535964006}"/>
              </a:ext>
            </a:extLst>
          </p:cNvPr>
          <p:cNvSpPr/>
          <p:nvPr/>
        </p:nvSpPr>
        <p:spPr>
          <a:xfrm>
            <a:off x="1184723" y="6928289"/>
            <a:ext cx="4636868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Figure S2</a:t>
            </a:r>
            <a:r>
              <a:rPr lang="en-US" sz="1200" dirty="0"/>
              <a:t>. PCR analysis of mutations in five BAM genes in Arabidopsis. T-DNA insertions in </a:t>
            </a:r>
            <a:r>
              <a:rPr lang="en-US" sz="1200" i="1" dirty="0"/>
              <a:t>BAM1</a:t>
            </a:r>
            <a:r>
              <a:rPr lang="en-US" sz="1200" dirty="0"/>
              <a:t>, </a:t>
            </a:r>
            <a:r>
              <a:rPr lang="en-US" sz="1200" i="1" dirty="0"/>
              <a:t>-2</a:t>
            </a:r>
            <a:r>
              <a:rPr lang="en-US" sz="1200" dirty="0"/>
              <a:t>, </a:t>
            </a:r>
            <a:r>
              <a:rPr lang="en-US" sz="1200" i="1" dirty="0"/>
              <a:t>-5,</a:t>
            </a:r>
            <a:r>
              <a:rPr lang="en-US" sz="1200" dirty="0"/>
              <a:t> and </a:t>
            </a:r>
            <a:r>
              <a:rPr lang="en-US" sz="1200" i="1" dirty="0"/>
              <a:t>-6</a:t>
            </a:r>
            <a:r>
              <a:rPr lang="en-US" sz="1200" dirty="0"/>
              <a:t> are indicated by one or two faster migrating bands. The </a:t>
            </a:r>
            <a:r>
              <a:rPr lang="en-US" sz="1200" i="1" dirty="0"/>
              <a:t>BAM3</a:t>
            </a:r>
            <a:r>
              <a:rPr lang="en-US" sz="1200" dirty="0"/>
              <a:t> point mutation destroys an </a:t>
            </a:r>
            <a:r>
              <a:rPr lang="en-US" sz="1200" dirty="0" err="1"/>
              <a:t>BsrI</a:t>
            </a:r>
            <a:r>
              <a:rPr lang="en-US" sz="1200" dirty="0"/>
              <a:t> restriction site resulting in a slower migrating band after digestion of the PCR product. </a:t>
            </a:r>
          </a:p>
        </p:txBody>
      </p:sp>
    </p:spTree>
    <p:extLst>
      <p:ext uri="{BB962C8B-B14F-4D97-AF65-F5344CB8AC3E}">
        <p14:creationId xmlns:p14="http://schemas.microsoft.com/office/powerpoint/2010/main" val="37106715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Rectangle 17">
            <a:extLst>
              <a:ext uri="{FF2B5EF4-FFF2-40B4-BE49-F238E27FC236}">
                <a16:creationId xmlns:a16="http://schemas.microsoft.com/office/drawing/2014/main" id="{385607B0-6C14-3446-AA19-22369203BAE1}"/>
              </a:ext>
            </a:extLst>
          </p:cNvPr>
          <p:cNvSpPr/>
          <p:nvPr/>
        </p:nvSpPr>
        <p:spPr>
          <a:xfrm>
            <a:off x="922158" y="7450528"/>
            <a:ext cx="5393801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Figure S3</a:t>
            </a:r>
            <a:r>
              <a:rPr lang="en-US" sz="1200" dirty="0"/>
              <a:t>. Effect of photoperiod on transcript levels of </a:t>
            </a:r>
            <a:r>
              <a:rPr lang="en-US" sz="1200" i="1" dirty="0"/>
              <a:t>BAM1</a:t>
            </a:r>
            <a:r>
              <a:rPr lang="en-US" sz="1200" dirty="0"/>
              <a:t> (A) and </a:t>
            </a:r>
            <a:r>
              <a:rPr lang="en-US" sz="1200" i="1" dirty="0"/>
              <a:t>BAM3</a:t>
            </a:r>
            <a:r>
              <a:rPr lang="en-US" sz="1200" dirty="0"/>
              <a:t> (B) over 24 h in 29 (gray circles) and 35 (black circles) day-old Arabidopsis plants. Points are means from three experiments +/- SD. Data are from Smith et al. (2004) (gray circles) and </a:t>
            </a:r>
            <a:r>
              <a:rPr lang="en-US" sz="1200" dirty="0" err="1"/>
              <a:t>Bläsing</a:t>
            </a:r>
            <a:r>
              <a:rPr lang="en-US" sz="1200" dirty="0"/>
              <a:t> et al. (2005) (black circles).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ED59295B-EE0E-5846-A6DA-3C0CB1FB5D52}"/>
              </a:ext>
            </a:extLst>
          </p:cNvPr>
          <p:cNvGrpSpPr/>
          <p:nvPr/>
        </p:nvGrpSpPr>
        <p:grpSpPr>
          <a:xfrm>
            <a:off x="879256" y="557302"/>
            <a:ext cx="4901939" cy="6437158"/>
            <a:chOff x="879256" y="557302"/>
            <a:chExt cx="4901939" cy="6437158"/>
          </a:xfrm>
        </p:grpSpPr>
        <p:graphicFrame>
          <p:nvGraphicFramePr>
            <p:cNvPr id="19" name="Chart 18">
              <a:extLst>
                <a:ext uri="{FF2B5EF4-FFF2-40B4-BE49-F238E27FC236}">
                  <a16:creationId xmlns:a16="http://schemas.microsoft.com/office/drawing/2014/main" id="{853A4EE2-EC1D-5B47-99BB-2BB6958910D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33308971"/>
                </p:ext>
              </p:extLst>
            </p:nvPr>
          </p:nvGraphicFramePr>
          <p:xfrm>
            <a:off x="1198573" y="3912706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13" name="Chart 12">
              <a:extLst>
                <a:ext uri="{FF2B5EF4-FFF2-40B4-BE49-F238E27FC236}">
                  <a16:creationId xmlns:a16="http://schemas.microsoft.com/office/drawing/2014/main" id="{1BF82AB1-7B75-FF46-B8C2-955E188D224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80354337"/>
                </p:ext>
              </p:extLst>
            </p:nvPr>
          </p:nvGraphicFramePr>
          <p:xfrm>
            <a:off x="1209195" y="716998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85FA66AF-FF42-4C49-85F3-D7FA6636A271}"/>
                </a:ext>
              </a:extLst>
            </p:cNvPr>
            <p:cNvSpPr txBox="1"/>
            <p:nvPr/>
          </p:nvSpPr>
          <p:spPr>
            <a:xfrm rot="16200000">
              <a:off x="357221" y="1702574"/>
              <a:ext cx="138262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Relative Signal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7E8A5D98-173C-E241-BCE8-7D8EE983C656}"/>
                </a:ext>
              </a:extLst>
            </p:cNvPr>
            <p:cNvSpPr txBox="1"/>
            <p:nvPr/>
          </p:nvSpPr>
          <p:spPr>
            <a:xfrm rot="16200000">
              <a:off x="357221" y="5192142"/>
              <a:ext cx="138262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Relative Signal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E9B42FC-EB92-8B4D-ACC6-284E3546CCC4}"/>
                </a:ext>
              </a:extLst>
            </p:cNvPr>
            <p:cNvSpPr txBox="1"/>
            <p:nvPr/>
          </p:nvSpPr>
          <p:spPr>
            <a:xfrm>
              <a:off x="893682" y="557302"/>
              <a:ext cx="3097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A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EA4079F-AE9F-8C4E-BFB0-1195895C0E1C}"/>
                </a:ext>
              </a:extLst>
            </p:cNvPr>
            <p:cNvSpPr txBox="1"/>
            <p:nvPr/>
          </p:nvSpPr>
          <p:spPr>
            <a:xfrm>
              <a:off x="898491" y="3820542"/>
              <a:ext cx="30008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B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BA340F1B-1C50-8F47-BE6C-D441EB30095B}"/>
                </a:ext>
              </a:extLst>
            </p:cNvPr>
            <p:cNvSpPr txBox="1"/>
            <p:nvPr/>
          </p:nvSpPr>
          <p:spPr>
            <a:xfrm>
              <a:off x="2934959" y="3455581"/>
              <a:ext cx="143443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Time of day (h)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E8B0F48-853A-3741-94E3-12DCED6B70C2}"/>
                </a:ext>
              </a:extLst>
            </p:cNvPr>
            <p:cNvSpPr txBox="1"/>
            <p:nvPr/>
          </p:nvSpPr>
          <p:spPr>
            <a:xfrm>
              <a:off x="4914784" y="2735463"/>
              <a:ext cx="64139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BAM1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DAB0EC4-E2E8-984A-AA10-7F6265C1E84E}"/>
                </a:ext>
              </a:extLst>
            </p:cNvPr>
            <p:cNvSpPr txBox="1"/>
            <p:nvPr/>
          </p:nvSpPr>
          <p:spPr>
            <a:xfrm>
              <a:off x="4914784" y="5935557"/>
              <a:ext cx="64139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BAM3</a:t>
              </a: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EF043BDD-A2B4-AB44-BD1E-953FBDCE6DAD}"/>
                </a:ext>
              </a:extLst>
            </p:cNvPr>
            <p:cNvGrpSpPr/>
            <p:nvPr/>
          </p:nvGrpSpPr>
          <p:grpSpPr>
            <a:xfrm>
              <a:off x="1740137" y="811101"/>
              <a:ext cx="3809325" cy="276999"/>
              <a:chOff x="1740137" y="809272"/>
              <a:chExt cx="3809325" cy="276999"/>
            </a:xfrm>
          </p:grpSpPr>
          <p:sp>
            <p:nvSpPr>
              <p:cNvPr id="20" name="Rectangle 19">
                <a:extLst>
                  <a:ext uri="{FF2B5EF4-FFF2-40B4-BE49-F238E27FC236}">
                    <a16:creationId xmlns:a16="http://schemas.microsoft.com/office/drawing/2014/main" id="{26722F54-4CD1-3B47-B058-C0B092FD1FF2}"/>
                  </a:ext>
                </a:extLst>
              </p:cNvPr>
              <p:cNvSpPr/>
              <p:nvPr/>
            </p:nvSpPr>
            <p:spPr>
              <a:xfrm>
                <a:off x="1740137" y="874618"/>
                <a:ext cx="1911880" cy="150688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4CE42ADA-66D4-9B44-9B23-2F8A2A4DA414}"/>
                  </a:ext>
                </a:extLst>
              </p:cNvPr>
              <p:cNvSpPr/>
              <p:nvPr/>
            </p:nvSpPr>
            <p:spPr>
              <a:xfrm>
                <a:off x="3623379" y="883084"/>
                <a:ext cx="1926083" cy="144913"/>
              </a:xfrm>
              <a:prstGeom prst="rect">
                <a:avLst/>
              </a:prstGeom>
              <a:solidFill>
                <a:schemeClr val="tx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6EF453D2-B0F0-1442-B4F3-EF8BB909ED13}"/>
                  </a:ext>
                </a:extLst>
              </p:cNvPr>
              <p:cNvSpPr txBox="1"/>
              <p:nvPr/>
            </p:nvSpPr>
            <p:spPr>
              <a:xfrm>
                <a:off x="2458414" y="809272"/>
                <a:ext cx="42716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Day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3DDC724A-08B9-AC4D-8419-18125405D0B1}"/>
                  </a:ext>
                </a:extLst>
              </p:cNvPr>
              <p:cNvSpPr txBox="1"/>
              <p:nvPr/>
            </p:nvSpPr>
            <p:spPr>
              <a:xfrm>
                <a:off x="4326201" y="809272"/>
                <a:ext cx="5327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schemeClr val="bg1"/>
                    </a:solidFill>
                  </a:rPr>
                  <a:t>Night</a:t>
                </a:r>
              </a:p>
            </p:txBody>
          </p:sp>
        </p:grp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E2DFE21C-97C1-D846-9A3E-DB8DE8E1B3D1}"/>
                </a:ext>
              </a:extLst>
            </p:cNvPr>
            <p:cNvSpPr txBox="1"/>
            <p:nvPr/>
          </p:nvSpPr>
          <p:spPr>
            <a:xfrm>
              <a:off x="2934959" y="6655906"/>
              <a:ext cx="143443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Time of day (h)</a:t>
              </a:r>
            </a:p>
          </p:txBody>
        </p: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75703971-BE4F-0F41-9015-8F2CFE178690}"/>
                </a:ext>
              </a:extLst>
            </p:cNvPr>
            <p:cNvGrpSpPr/>
            <p:nvPr/>
          </p:nvGrpSpPr>
          <p:grpSpPr>
            <a:xfrm>
              <a:off x="1728565" y="4008231"/>
              <a:ext cx="3826728" cy="276999"/>
              <a:chOff x="1740137" y="809272"/>
              <a:chExt cx="3826728" cy="276999"/>
            </a:xfrm>
          </p:grpSpPr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0B1748F5-1D85-0940-BCAA-4F80E59B097A}"/>
                  </a:ext>
                </a:extLst>
              </p:cNvPr>
              <p:cNvSpPr/>
              <p:nvPr/>
            </p:nvSpPr>
            <p:spPr>
              <a:xfrm>
                <a:off x="1740137" y="874618"/>
                <a:ext cx="1911880" cy="150688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7A938CB6-79D0-0146-8DB0-071F0F019D60}"/>
                  </a:ext>
                </a:extLst>
              </p:cNvPr>
              <p:cNvSpPr/>
              <p:nvPr/>
            </p:nvSpPr>
            <p:spPr>
              <a:xfrm>
                <a:off x="3623379" y="870558"/>
                <a:ext cx="1943486" cy="151754"/>
              </a:xfrm>
              <a:prstGeom prst="rect">
                <a:avLst/>
              </a:prstGeom>
              <a:solidFill>
                <a:schemeClr val="tx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61C8B56A-B410-0C44-8A78-DFB5921EA090}"/>
                  </a:ext>
                </a:extLst>
              </p:cNvPr>
              <p:cNvSpPr txBox="1"/>
              <p:nvPr/>
            </p:nvSpPr>
            <p:spPr>
              <a:xfrm>
                <a:off x="2458414" y="809272"/>
                <a:ext cx="42716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Day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4E558AC1-F392-1A48-97E1-D71B0CF88D2E}"/>
                  </a:ext>
                </a:extLst>
              </p:cNvPr>
              <p:cNvSpPr txBox="1"/>
              <p:nvPr/>
            </p:nvSpPr>
            <p:spPr>
              <a:xfrm>
                <a:off x="4326201" y="809272"/>
                <a:ext cx="5327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schemeClr val="bg1"/>
                    </a:solidFill>
                  </a:rPr>
                  <a:t>Night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8507735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24476FB0-522A-8B4E-940B-48B31BF5554A}"/>
              </a:ext>
            </a:extLst>
          </p:cNvPr>
          <p:cNvGrpSpPr/>
          <p:nvPr/>
        </p:nvGrpSpPr>
        <p:grpSpPr>
          <a:xfrm>
            <a:off x="879256" y="636134"/>
            <a:ext cx="4907752" cy="6480117"/>
            <a:chOff x="879256" y="636134"/>
            <a:chExt cx="4907752" cy="6480117"/>
          </a:xfrm>
        </p:grpSpPr>
        <p:graphicFrame>
          <p:nvGraphicFramePr>
            <p:cNvPr id="4" name="Chart 3">
              <a:extLst>
                <a:ext uri="{FF2B5EF4-FFF2-40B4-BE49-F238E27FC236}">
                  <a16:creationId xmlns:a16="http://schemas.microsoft.com/office/drawing/2014/main" id="{DD539A13-F6E5-324C-A41C-4DC446F993E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35630925"/>
                </p:ext>
              </p:extLst>
            </p:nvPr>
          </p:nvGraphicFramePr>
          <p:xfrm>
            <a:off x="1230248" y="4087263"/>
            <a:ext cx="455676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Chart 4">
              <a:extLst>
                <a:ext uri="{FF2B5EF4-FFF2-40B4-BE49-F238E27FC236}">
                  <a16:creationId xmlns:a16="http://schemas.microsoft.com/office/drawing/2014/main" id="{4F2D8F9A-C163-4B49-8B0A-001B820D125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82005332"/>
                </p:ext>
              </p:extLst>
            </p:nvPr>
          </p:nvGraphicFramePr>
          <p:xfrm>
            <a:off x="1230248" y="832795"/>
            <a:ext cx="455676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85FA66AF-FF42-4C49-85F3-D7FA6636A271}"/>
                </a:ext>
              </a:extLst>
            </p:cNvPr>
            <p:cNvSpPr txBox="1"/>
            <p:nvPr/>
          </p:nvSpPr>
          <p:spPr>
            <a:xfrm rot="16200000">
              <a:off x="357221" y="1781407"/>
              <a:ext cx="138262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Relative Signal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7E8A5D98-173C-E241-BCE8-7D8EE983C656}"/>
                </a:ext>
              </a:extLst>
            </p:cNvPr>
            <p:cNvSpPr txBox="1"/>
            <p:nvPr/>
          </p:nvSpPr>
          <p:spPr>
            <a:xfrm rot="16200000">
              <a:off x="357221" y="5270975"/>
              <a:ext cx="138262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Relative Signal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C3E7599-B1BE-8946-9BA7-F9265D97F8CF}"/>
                </a:ext>
              </a:extLst>
            </p:cNvPr>
            <p:cNvSpPr txBox="1"/>
            <p:nvPr/>
          </p:nvSpPr>
          <p:spPr>
            <a:xfrm>
              <a:off x="1916258" y="6777697"/>
              <a:ext cx="322376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Duration of cold stress treatment (h)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E9B42FC-EB92-8B4D-ACC6-284E3546CCC4}"/>
                </a:ext>
              </a:extLst>
            </p:cNvPr>
            <p:cNvSpPr txBox="1"/>
            <p:nvPr/>
          </p:nvSpPr>
          <p:spPr>
            <a:xfrm>
              <a:off x="893682" y="636134"/>
              <a:ext cx="3097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A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EA4079F-AE9F-8C4E-BFB0-1195895C0E1C}"/>
                </a:ext>
              </a:extLst>
            </p:cNvPr>
            <p:cNvSpPr txBox="1"/>
            <p:nvPr/>
          </p:nvSpPr>
          <p:spPr>
            <a:xfrm>
              <a:off x="898491" y="3899375"/>
              <a:ext cx="30008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B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BA340F1B-1C50-8F47-BE6C-D441EB30095B}"/>
                </a:ext>
              </a:extLst>
            </p:cNvPr>
            <p:cNvSpPr txBox="1"/>
            <p:nvPr/>
          </p:nvSpPr>
          <p:spPr>
            <a:xfrm>
              <a:off x="2060090" y="3505161"/>
              <a:ext cx="353968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Duration of osmotic stress treatment (h)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E8B0F48-853A-3741-94E3-12DCED6B70C2}"/>
                </a:ext>
              </a:extLst>
            </p:cNvPr>
            <p:cNvSpPr txBox="1"/>
            <p:nvPr/>
          </p:nvSpPr>
          <p:spPr>
            <a:xfrm>
              <a:off x="1765508" y="4258344"/>
              <a:ext cx="64139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BAM3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DAB0EC4-E2E8-984A-AA10-7F6265C1E84E}"/>
                </a:ext>
              </a:extLst>
            </p:cNvPr>
            <p:cNvSpPr txBox="1"/>
            <p:nvPr/>
          </p:nvSpPr>
          <p:spPr>
            <a:xfrm>
              <a:off x="1765508" y="1018256"/>
              <a:ext cx="64139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BAM1</a:t>
              </a:r>
            </a:p>
          </p:txBody>
        </p:sp>
      </p:grpSp>
      <p:sp>
        <p:nvSpPr>
          <p:cNvPr id="18" name="Rectangle 17">
            <a:extLst>
              <a:ext uri="{FF2B5EF4-FFF2-40B4-BE49-F238E27FC236}">
                <a16:creationId xmlns:a16="http://schemas.microsoft.com/office/drawing/2014/main" id="{385607B0-6C14-3446-AA19-22369203BAE1}"/>
              </a:ext>
            </a:extLst>
          </p:cNvPr>
          <p:cNvSpPr/>
          <p:nvPr/>
        </p:nvSpPr>
        <p:spPr>
          <a:xfrm>
            <a:off x="922158" y="7529361"/>
            <a:ext cx="5393801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Figure S4</a:t>
            </a:r>
            <a:r>
              <a:rPr lang="en-US" sz="1200" dirty="0"/>
              <a:t>. Effect of abiotic stress on BAM1 and BAM3 transcript levels over 24 h in 18 day-old Arabidopsis plants. A. Response of BAM1 transcript to 300 mM mannitol (osmotic) stress. B. Response of BAM3 transcript to 4℃ (cold) stress. Points are means from three experiments +/- SD. Data are from Kilian et al. (2007).</a:t>
            </a:r>
          </a:p>
        </p:txBody>
      </p:sp>
    </p:spTree>
    <p:extLst>
      <p:ext uri="{BB962C8B-B14F-4D97-AF65-F5344CB8AC3E}">
        <p14:creationId xmlns:p14="http://schemas.microsoft.com/office/powerpoint/2010/main" val="39235522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184</TotalTime>
  <Words>347</Words>
  <Application>Microsoft Macintosh PowerPoint</Application>
  <PresentationFormat>Letter Paper (8.5x11 in)</PresentationFormat>
  <Paragraphs>65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nroe, Jonathan D - monroejd</dc:creator>
  <cp:lastModifiedBy>Monroe, Jonathan D - monroejd</cp:lastModifiedBy>
  <cp:revision>103</cp:revision>
  <cp:lastPrinted>2019-07-18T14:34:22Z</cp:lastPrinted>
  <dcterms:created xsi:type="dcterms:W3CDTF">2019-05-22T16:56:42Z</dcterms:created>
  <dcterms:modified xsi:type="dcterms:W3CDTF">2019-09-08T15:23:06Z</dcterms:modified>
</cp:coreProperties>
</file>